
<file path=[Content_Types].xml><?xml version="1.0" encoding="utf-8"?>
<Types xmlns="http://schemas.openxmlformats.org/package/2006/content-types">
  <Default Extension="emf" ContentType="image/x-emf"/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4"/>
  </p:sldMasterIdLst>
  <p:notesMasterIdLst>
    <p:notesMasterId r:id="rId21"/>
  </p:notesMasterIdLst>
  <p:handoutMasterIdLst>
    <p:handoutMasterId r:id="rId22"/>
  </p:handoutMasterIdLst>
  <p:sldIdLst>
    <p:sldId id="580" r:id="rId5"/>
    <p:sldId id="544" r:id="rId6"/>
    <p:sldId id="582" r:id="rId7"/>
    <p:sldId id="583" r:id="rId8"/>
    <p:sldId id="574" r:id="rId9"/>
    <p:sldId id="575" r:id="rId10"/>
    <p:sldId id="576" r:id="rId11"/>
    <p:sldId id="545" r:id="rId12"/>
    <p:sldId id="557" r:id="rId13"/>
    <p:sldId id="577" r:id="rId14"/>
    <p:sldId id="584" r:id="rId15"/>
    <p:sldId id="291" r:id="rId16"/>
    <p:sldId id="300" r:id="rId17"/>
    <p:sldId id="578" r:id="rId18"/>
    <p:sldId id="585" r:id="rId19"/>
    <p:sldId id="579" r:id="rId20"/>
  </p:sldIdLst>
  <p:sldSz cx="12192000" cy="6858000"/>
  <p:notesSz cx="6858000" cy="9144000"/>
  <p:embeddedFontLst>
    <p:embeddedFont>
      <p:font typeface="Arial Nova" panose="020B0504020202020204" pitchFamily="34" charset="0"/>
      <p:regular r:id="rId23"/>
      <p:bold r:id="rId24"/>
      <p:italic r:id="rId25"/>
      <p:boldItalic r:id="rId26"/>
    </p:embeddedFont>
    <p:embeddedFont>
      <p:font typeface="Calibri" panose="020F0502020204030204" pitchFamily="34" charset="0"/>
      <p:regular r:id="rId27"/>
      <p:bold r:id="rId28"/>
      <p:italic r:id="rId29"/>
      <p:boldItalic r:id="rId30"/>
    </p:embeddedFont>
    <p:embeddedFont>
      <p:font typeface="Gill Sans MT" panose="020B0502020104020203" pitchFamily="34" charset="77"/>
      <p:regular r:id="rId31"/>
      <p:bold r:id="rId32"/>
      <p:italic r:id="rId33"/>
      <p:boldItalic r:id="rId34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BA4DB"/>
    <a:srgbClr val="000000"/>
    <a:srgbClr val="FFCF34"/>
    <a:srgbClr val="B981B9"/>
    <a:srgbClr val="88C65B"/>
    <a:srgbClr val="F0EBE7"/>
    <a:srgbClr val="767679"/>
    <a:srgbClr val="0064A4"/>
    <a:srgbClr val="56595A"/>
    <a:srgbClr val="233F7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15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57" autoAdjust="0"/>
    <p:restoredTop sz="85986" autoAdjust="0"/>
  </p:normalViewPr>
  <p:slideViewPr>
    <p:cSldViewPr snapToGrid="0">
      <p:cViewPr varScale="1">
        <p:scale>
          <a:sx n="105" d="100"/>
          <a:sy n="105" d="100"/>
        </p:scale>
        <p:origin x="1368" y="18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32" d="100"/>
        <a:sy n="132" d="100"/>
      </p:scale>
      <p:origin x="0" y="0"/>
    </p:cViewPr>
  </p:sorter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font" Target="fonts/font4.fntdata"/><Relationship Id="rId21" Type="http://schemas.openxmlformats.org/officeDocument/2006/relationships/notesMaster" Target="notesMasters/notesMaster1.xml"/><Relationship Id="rId34" Type="http://schemas.openxmlformats.org/officeDocument/2006/relationships/font" Target="fonts/font12.fntdata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font" Target="fonts/font3.fntdata"/><Relationship Id="rId33" Type="http://schemas.openxmlformats.org/officeDocument/2006/relationships/font" Target="fonts/font11.fntdata"/><Relationship Id="rId38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font" Target="fonts/font7.fntdata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font" Target="fonts/font2.fntdata"/><Relationship Id="rId32" Type="http://schemas.openxmlformats.org/officeDocument/2006/relationships/font" Target="fonts/font10.fntdata"/><Relationship Id="rId37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font" Target="fonts/font1.fntdata"/><Relationship Id="rId28" Type="http://schemas.openxmlformats.org/officeDocument/2006/relationships/font" Target="fonts/font6.fntdata"/><Relationship Id="rId36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font" Target="fonts/font9.fntdata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handoutMaster" Target="handoutMasters/handoutMaster1.xml"/><Relationship Id="rId27" Type="http://schemas.openxmlformats.org/officeDocument/2006/relationships/font" Target="fonts/font5.fntdata"/><Relationship Id="rId30" Type="http://schemas.openxmlformats.org/officeDocument/2006/relationships/font" Target="fonts/font8.fntdata"/><Relationship Id="rId35" Type="http://schemas.openxmlformats.org/officeDocument/2006/relationships/presProps" Target="presProps.xml"/><Relationship Id="rId8" Type="http://schemas.openxmlformats.org/officeDocument/2006/relationships/slide" Target="slides/slide4.xml"/><Relationship Id="rId3" Type="http://schemas.openxmlformats.org/officeDocument/2006/relationships/customXml" Target="../customXml/item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75785248-8608-4103-9F46-6314B8C2090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>
              <a:latin typeface="Gill Sans MT" panose="020B0502020104020203" pitchFamily="34" charset="0"/>
            </a:endParaRP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306627-CB46-4633-ABEE-7CFB5A4C674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E13D4A-60A8-41EB-8450-246078E8F7C4}" type="datetimeFigureOut">
              <a:rPr lang="en-US" smtClean="0">
                <a:latin typeface="Gill Sans MT" panose="020B0502020104020203" pitchFamily="34" charset="0"/>
              </a:rPr>
              <a:t>1/18/23</a:t>
            </a:fld>
            <a:endParaRPr lang="en-US">
              <a:latin typeface="Gill Sans MT" panose="020B0502020104020203" pitchFamily="34" charset="0"/>
            </a:endParaRP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846F890-478B-4898-A8B9-947ECCDACF2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>
              <a:latin typeface="Gill Sans MT" panose="020B0502020104020203" pitchFamily="34" charset="0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07942E-7C71-48B0-99CD-B1C842863D6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8FF0CB-2BE4-4232-ADD5-BD1BCE4113F9}" type="slidenum">
              <a:rPr lang="en-US" smtClean="0">
                <a:latin typeface="Gill Sans MT" panose="020B0502020104020203" pitchFamily="34" charset="0"/>
              </a:rPr>
              <a:t>‹#›</a:t>
            </a:fld>
            <a:endParaRPr lang="en-US">
              <a:latin typeface="Gill Sans MT" panose="020B05020201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51451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Gill Sans MT" panose="020B0502020104020203" pitchFamily="34" charset="0"/>
              </a:defRPr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Gill Sans MT" panose="020B0502020104020203" pitchFamily="34" charset="0"/>
              </a:defRPr>
            </a:lvl1pPr>
          </a:lstStyle>
          <a:p>
            <a:fld id="{D07D4DF1-1162-4863-B4DA-2D976C3025F7}" type="datetimeFigureOut">
              <a:rPr lang="en-US" smtClean="0"/>
              <a:pPr/>
              <a:t>1/1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Gill Sans MT" panose="020B0502020104020203" pitchFamily="34" charset="0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Gill Sans MT" panose="020B0502020104020203" pitchFamily="34" charset="0"/>
              </a:defRPr>
            </a:lvl1pPr>
          </a:lstStyle>
          <a:p>
            <a:fld id="{74C81EBE-2326-44BA-9706-72A407557C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69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Gill Sans MT" panose="020B0502020104020203" pitchFamily="34" charset="0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Gill Sans MT" panose="020B0502020104020203" pitchFamily="34" charset="0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Gill Sans MT" panose="020B0502020104020203" pitchFamily="34" charset="0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Gill Sans MT" panose="020B0502020104020203" pitchFamily="34" charset="0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Gill Sans MT" panose="020B0502020104020203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tory of how the patient was injured. 3-month-old infant developmental milestones: should not be able to fall off a bed on their own. 4-6 months rolls from front to back. </a:t>
            </a:r>
          </a:p>
          <a:p>
            <a:r>
              <a:rPr lang="en-US" dirty="0"/>
              <a:t>Lack of supervision: infant left with other minors while she went to the store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04842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 our county EMSA requires online medical control for children with suspected physical or sexual abuse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816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Neglect – the patient was not provided with breakfast</a:t>
            </a:r>
          </a:p>
          <a:p>
            <a:r>
              <a:rPr lang="en-US" dirty="0"/>
              <a:t>Physical abuse – pushed: head hit bed frame, bruising to leg and feet.</a:t>
            </a:r>
          </a:p>
          <a:p>
            <a:r>
              <a:rPr lang="en-US" dirty="0"/>
              <a:t>Emotional abuse – domestic dispute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4181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spected physical abuse requires online medical control by County EMS polic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17276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ediatric patient with burns – unknown as to how the patient was burnt? Not enough info to know if the burns were patterned or not?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4533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unty EMS policy review. If you have knowledge of suspected abuse, you must file your own repor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82290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Evaluating pediatric patient’s risk for abuse. Children are an inherently vulnerable patient population. This age is even more so…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08529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ing county EMS polic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82433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Reviewing county EMS polic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16579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Reviewing county EMS polic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81EBE-2326-44BA-9706-72A407557CC4}" type="slidenum">
              <a:rPr lang="en-US" smtClean="0"/>
              <a:pPr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976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">
    <p:bg>
      <p:bgPr>
        <a:solidFill>
          <a:srgbClr val="3466C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PT_SLIDE_ACCENT_CHOCO_BLUE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19" name="Subtitle 2">
            <a:extLst>
              <a:ext uri="{FF2B5EF4-FFF2-40B4-BE49-F238E27FC236}">
                <a16:creationId xmlns:a16="http://schemas.microsoft.com/office/drawing/2014/main" id="{A9A03017-0DA7-2247-AEF6-ACD20A8A12C1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5466080" y="3880010"/>
            <a:ext cx="6725920" cy="325651"/>
          </a:xfrm>
        </p:spPr>
        <p:txBody>
          <a:bodyPr anchor="ctr">
            <a:normAutofit/>
          </a:bodyPr>
          <a:lstStyle>
            <a:lvl1pPr marL="0" indent="0" algn="l">
              <a:buNone/>
              <a:defRPr sz="1600">
                <a:solidFill>
                  <a:schemeClr val="bg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00.00.00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5466080" y="2774609"/>
            <a:ext cx="6725920" cy="1096351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3200" b="0" i="0" spc="600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PRESENTATION TITLE GOES HERE</a:t>
            </a:r>
          </a:p>
        </p:txBody>
      </p:sp>
      <p:cxnSp>
        <p:nvCxnSpPr>
          <p:cNvPr id="11" name="Straight Connector 10"/>
          <p:cNvCxnSpPr/>
          <p:nvPr userDrawn="1"/>
        </p:nvCxnSpPr>
        <p:spPr>
          <a:xfrm>
            <a:off x="5130800" y="2743200"/>
            <a:ext cx="0" cy="146304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CHOC_Logo_RGB_White.eps"/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6110" y="2761196"/>
            <a:ext cx="4108450" cy="1112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7732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CHOCO SING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PT_SLIDE_SECTION_CHOCO_SINGING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2011255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CHOCO EAT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PT_SLIDE_SECTION_CHOCO_EATING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192548043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+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FAC1B7-7A7F-244A-985F-8905B0C641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88453" y="1825625"/>
            <a:ext cx="11215867" cy="4003675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D1F62738-8DF1-E642-8DCD-13DFB31F6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8453" y="365125"/>
            <a:ext cx="11215867" cy="1325563"/>
          </a:xfrm>
        </p:spPr>
        <p:txBody>
          <a:bodyPr>
            <a:normAutofit/>
          </a:bodyPr>
          <a:lstStyle>
            <a:lvl1pPr>
              <a:defRPr sz="4000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56601222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77E80A-3986-FC4B-A547-8DC058C19D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88453" y="1825625"/>
            <a:ext cx="5531347" cy="39782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47DA30-96A6-1D4E-BFEE-C0737CA287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199" y="1825625"/>
            <a:ext cx="5534399" cy="397827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D1F62738-8DF1-E642-8DCD-13DFB31F6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8453" y="365125"/>
            <a:ext cx="11215094" cy="1325563"/>
          </a:xfrm>
        </p:spPr>
        <p:txBody>
          <a:bodyPr>
            <a:normAutofit/>
          </a:bodyPr>
          <a:lstStyle>
            <a:lvl1pPr>
              <a:defRPr sz="4000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43543781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+ 1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D1F62738-8DF1-E642-8DCD-13DFB31F6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7680" y="365125"/>
            <a:ext cx="7138057" cy="1325563"/>
          </a:xfrm>
        </p:spPr>
        <p:txBody>
          <a:bodyPr>
            <a:normAutofit/>
          </a:bodyPr>
          <a:lstStyle>
            <a:lvl1pPr>
              <a:defRPr sz="4000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67FAC1B7-7A7F-244A-985F-8905B0C6413D}"/>
              </a:ext>
            </a:extLst>
          </p:cNvPr>
          <p:cNvSpPr>
            <a:spLocks noGrp="1"/>
          </p:cNvSpPr>
          <p:nvPr>
            <p:ph idx="11"/>
          </p:nvPr>
        </p:nvSpPr>
        <p:spPr>
          <a:xfrm>
            <a:off x="487680" y="1825625"/>
            <a:ext cx="7138057" cy="4003675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Picture Placeholder 2">
            <a:extLst>
              <a:ext uri="{FF2B5EF4-FFF2-40B4-BE49-F238E27FC236}">
                <a16:creationId xmlns:a16="http://schemas.microsoft.com/office/drawing/2014/main" id="{297E72FB-715D-4746-9924-1F3FCC5244B0}"/>
              </a:ext>
            </a:extLst>
          </p:cNvPr>
          <p:cNvSpPr>
            <a:spLocks noGrp="1"/>
          </p:cNvSpPr>
          <p:nvPr>
            <p:ph type="pic" idx="13"/>
          </p:nvPr>
        </p:nvSpPr>
        <p:spPr>
          <a:xfrm>
            <a:off x="7937366" y="0"/>
            <a:ext cx="4254633" cy="6858000"/>
          </a:xfrm>
        </p:spPr>
        <p:txBody>
          <a:bodyPr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278237582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+ 2 IMAG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>
            <a:extLst>
              <a:ext uri="{FF2B5EF4-FFF2-40B4-BE49-F238E27FC236}">
                <a16:creationId xmlns:a16="http://schemas.microsoft.com/office/drawing/2014/main" id="{D1F62738-8DF1-E642-8DCD-13DFB31F6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7680" y="365125"/>
            <a:ext cx="7138057" cy="1325563"/>
          </a:xfrm>
        </p:spPr>
        <p:txBody>
          <a:bodyPr>
            <a:normAutofit/>
          </a:bodyPr>
          <a:lstStyle>
            <a:lvl1pPr>
              <a:defRPr sz="4000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0" name="Content Placeholder 2">
            <a:extLst>
              <a:ext uri="{FF2B5EF4-FFF2-40B4-BE49-F238E27FC236}">
                <a16:creationId xmlns:a16="http://schemas.microsoft.com/office/drawing/2014/main" id="{67FAC1B7-7A7F-244A-985F-8905B0C6413D}"/>
              </a:ext>
            </a:extLst>
          </p:cNvPr>
          <p:cNvSpPr>
            <a:spLocks noGrp="1"/>
          </p:cNvSpPr>
          <p:nvPr>
            <p:ph idx="11"/>
          </p:nvPr>
        </p:nvSpPr>
        <p:spPr>
          <a:xfrm>
            <a:off x="487680" y="1825625"/>
            <a:ext cx="7138057" cy="4003675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4" name="Picture Placeholder 2">
            <a:extLst>
              <a:ext uri="{FF2B5EF4-FFF2-40B4-BE49-F238E27FC236}">
                <a16:creationId xmlns:a16="http://schemas.microsoft.com/office/drawing/2014/main" id="{297E72FB-715D-4746-9924-1F3FCC5244B0}"/>
              </a:ext>
            </a:extLst>
          </p:cNvPr>
          <p:cNvSpPr>
            <a:spLocks noGrp="1"/>
          </p:cNvSpPr>
          <p:nvPr>
            <p:ph type="pic" idx="12"/>
          </p:nvPr>
        </p:nvSpPr>
        <p:spPr>
          <a:xfrm>
            <a:off x="7937366" y="3427475"/>
            <a:ext cx="4254633" cy="3430526"/>
          </a:xfrm>
        </p:spPr>
        <p:txBody>
          <a:bodyPr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15" name="Picture Placeholder 2">
            <a:extLst>
              <a:ext uri="{FF2B5EF4-FFF2-40B4-BE49-F238E27FC236}">
                <a16:creationId xmlns:a16="http://schemas.microsoft.com/office/drawing/2014/main" id="{297E72FB-715D-4746-9924-1F3FCC5244B0}"/>
              </a:ext>
            </a:extLst>
          </p:cNvPr>
          <p:cNvSpPr>
            <a:spLocks noGrp="1"/>
          </p:cNvSpPr>
          <p:nvPr>
            <p:ph type="pic" idx="13"/>
          </p:nvPr>
        </p:nvSpPr>
        <p:spPr>
          <a:xfrm>
            <a:off x="7937366" y="0"/>
            <a:ext cx="4254633" cy="3430526"/>
          </a:xfrm>
        </p:spPr>
        <p:txBody>
          <a:bodyPr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141949216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| 3 IMAG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>
            <a:extLst>
              <a:ext uri="{FF2B5EF4-FFF2-40B4-BE49-F238E27FC236}">
                <a16:creationId xmlns:a16="http://schemas.microsoft.com/office/drawing/2014/main" id="{D1F62738-8DF1-E642-8DCD-13DFB31F6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7680" y="365125"/>
            <a:ext cx="7138057" cy="1325563"/>
          </a:xfrm>
        </p:spPr>
        <p:txBody>
          <a:bodyPr>
            <a:normAutofit/>
          </a:bodyPr>
          <a:lstStyle>
            <a:lvl1pPr>
              <a:defRPr sz="4000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0" name="Content Placeholder 2">
            <a:extLst>
              <a:ext uri="{FF2B5EF4-FFF2-40B4-BE49-F238E27FC236}">
                <a16:creationId xmlns:a16="http://schemas.microsoft.com/office/drawing/2014/main" id="{67FAC1B7-7A7F-244A-985F-8905B0C6413D}"/>
              </a:ext>
            </a:extLst>
          </p:cNvPr>
          <p:cNvSpPr>
            <a:spLocks noGrp="1"/>
          </p:cNvSpPr>
          <p:nvPr>
            <p:ph idx="11"/>
          </p:nvPr>
        </p:nvSpPr>
        <p:spPr>
          <a:xfrm>
            <a:off x="487680" y="1825625"/>
            <a:ext cx="7138057" cy="4003675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1" name="Picture Placeholder 2">
            <a:extLst>
              <a:ext uri="{FF2B5EF4-FFF2-40B4-BE49-F238E27FC236}">
                <a16:creationId xmlns:a16="http://schemas.microsoft.com/office/drawing/2014/main" id="{297E72FB-715D-4746-9924-1F3FCC5244B0}"/>
              </a:ext>
            </a:extLst>
          </p:cNvPr>
          <p:cNvSpPr>
            <a:spLocks noGrp="1"/>
          </p:cNvSpPr>
          <p:nvPr>
            <p:ph type="pic" idx="12"/>
          </p:nvPr>
        </p:nvSpPr>
        <p:spPr>
          <a:xfrm>
            <a:off x="7937367" y="3427475"/>
            <a:ext cx="2124774" cy="3430526"/>
          </a:xfrm>
        </p:spPr>
        <p:txBody>
          <a:bodyPr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12" name="Picture Placeholder 2">
            <a:extLst>
              <a:ext uri="{FF2B5EF4-FFF2-40B4-BE49-F238E27FC236}">
                <a16:creationId xmlns:a16="http://schemas.microsoft.com/office/drawing/2014/main" id="{297E72FB-715D-4746-9924-1F3FCC5244B0}"/>
              </a:ext>
            </a:extLst>
          </p:cNvPr>
          <p:cNvSpPr>
            <a:spLocks noGrp="1"/>
          </p:cNvSpPr>
          <p:nvPr>
            <p:ph type="pic" idx="13"/>
          </p:nvPr>
        </p:nvSpPr>
        <p:spPr>
          <a:xfrm>
            <a:off x="7937366" y="0"/>
            <a:ext cx="4254633" cy="3430526"/>
          </a:xfrm>
        </p:spPr>
        <p:txBody>
          <a:bodyPr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13" name="Picture Placeholder 2">
            <a:extLst>
              <a:ext uri="{FF2B5EF4-FFF2-40B4-BE49-F238E27FC236}">
                <a16:creationId xmlns:a16="http://schemas.microsoft.com/office/drawing/2014/main" id="{297E72FB-715D-4746-9924-1F3FCC5244B0}"/>
              </a:ext>
            </a:extLst>
          </p:cNvPr>
          <p:cNvSpPr>
            <a:spLocks noGrp="1"/>
          </p:cNvSpPr>
          <p:nvPr>
            <p:ph type="pic" idx="14"/>
          </p:nvPr>
        </p:nvSpPr>
        <p:spPr>
          <a:xfrm>
            <a:off x="10067226" y="3427475"/>
            <a:ext cx="2124774" cy="3430526"/>
          </a:xfrm>
        </p:spPr>
        <p:txBody>
          <a:bodyPr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237124964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+ BIG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icture Placeholder 3">
            <a:extLst>
              <a:ext uri="{FF2B5EF4-FFF2-40B4-BE49-F238E27FC236}">
                <a16:creationId xmlns:a16="http://schemas.microsoft.com/office/drawing/2014/main" id="{7F9329D0-097E-4591-97D6-2601E70ED9F5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0" y="1817732"/>
            <a:ext cx="12192000" cy="5040268"/>
          </a:xfrm>
        </p:spPr>
        <p:txBody>
          <a:bodyPr/>
          <a:lstStyle/>
          <a:p>
            <a:r>
              <a:rPr lang="en-US"/>
              <a:t>Click icon to add picture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D1F62738-8DF1-E642-8DCD-13DFB31F6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7680" y="365125"/>
            <a:ext cx="11368267" cy="1325563"/>
          </a:xfrm>
        </p:spPr>
        <p:txBody>
          <a:bodyPr>
            <a:normAutofit/>
          </a:bodyPr>
          <a:lstStyle>
            <a:lvl1pPr>
              <a:defRPr sz="4000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43622021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ULL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B733B8-09BF-4A0A-918F-A6246B8F8CE0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12192000" cy="6858000"/>
          </a:xfrm>
        </p:spPr>
        <p:txBody>
          <a:bodyPr/>
          <a:lstStyle/>
          <a:p>
            <a:r>
              <a:rPr lang="en-US"/>
              <a:t>Click icon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280098826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83720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INFA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PT_SLIDE_SECTION_INFANT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397051482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 |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PT_SLIDE_ACCENT_BLUE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17802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 | GRA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PT_SLIDE_ACCENT_GRAY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202554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CCENT |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PT_SLIDE_ACCENT_CHOCO_BLUE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36880" y="0"/>
            <a:ext cx="11297920" cy="5842000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1" spc="0" baseline="0">
                <a:solidFill>
                  <a:schemeClr val="bg1"/>
                </a:solidFill>
              </a:defRPr>
            </a:lvl1pPr>
          </a:lstStyle>
          <a:p>
            <a:r>
              <a:rPr lang="en-US" i="1" dirty="0">
                <a:solidFill>
                  <a:prstClr val="white"/>
                </a:solidFill>
              </a:rPr>
              <a:t>“Use this </a:t>
            </a:r>
            <a:r>
              <a:rPr lang="en-US" b="1" i="1" dirty="0">
                <a:solidFill>
                  <a:prstClr val="white"/>
                </a:solidFill>
              </a:rPr>
              <a:t>Accent Page</a:t>
            </a:r>
            <a:r>
              <a:rPr lang="en-US" i="1" dirty="0">
                <a:solidFill>
                  <a:prstClr val="white"/>
                </a:solidFill>
              </a:rPr>
              <a:t> to place emphasis or call attention to a big statement, message or quote.”</a:t>
            </a:r>
          </a:p>
        </p:txBody>
      </p:sp>
    </p:spTree>
    <p:extLst>
      <p:ext uri="{BB962C8B-B14F-4D97-AF65-F5344CB8AC3E}">
        <p14:creationId xmlns:p14="http://schemas.microsoft.com/office/powerpoint/2010/main" val="121473272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CCENT | GRA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PT_SLIDE_ACCENT_CHOCO_GRAY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12188952" cy="6858000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36880" y="0"/>
            <a:ext cx="11297920" cy="5842000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1" spc="0" baseline="0">
                <a:solidFill>
                  <a:schemeClr val="bg1"/>
                </a:solidFill>
              </a:defRPr>
            </a:lvl1pPr>
          </a:lstStyle>
          <a:p>
            <a:r>
              <a:rPr lang="en-US" i="1" dirty="0">
                <a:solidFill>
                  <a:prstClr val="white"/>
                </a:solidFill>
              </a:rPr>
              <a:t>“Use this </a:t>
            </a:r>
            <a:r>
              <a:rPr lang="en-US" b="1" i="1" dirty="0">
                <a:solidFill>
                  <a:prstClr val="white"/>
                </a:solidFill>
              </a:rPr>
              <a:t>Accent Page</a:t>
            </a:r>
            <a:r>
              <a:rPr lang="en-US" i="1" dirty="0">
                <a:solidFill>
                  <a:prstClr val="white"/>
                </a:solidFill>
              </a:rPr>
              <a:t> to place emphasis or call attention to a big statement, message or quote.”</a:t>
            </a:r>
          </a:p>
        </p:txBody>
      </p:sp>
    </p:spTree>
    <p:extLst>
      <p:ext uri="{BB962C8B-B14F-4D97-AF65-F5344CB8AC3E}">
        <p14:creationId xmlns:p14="http://schemas.microsoft.com/office/powerpoint/2010/main" val="2019314832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CCENT | GRE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PT_SLIDE_ACCENT_CHOCO_GREEN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36880" y="0"/>
            <a:ext cx="11297920" cy="5842000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1" spc="0" baseline="0">
                <a:solidFill>
                  <a:schemeClr val="bg1"/>
                </a:solidFill>
              </a:defRPr>
            </a:lvl1pPr>
          </a:lstStyle>
          <a:p>
            <a:r>
              <a:rPr lang="en-US" i="1" dirty="0">
                <a:solidFill>
                  <a:prstClr val="white"/>
                </a:solidFill>
              </a:rPr>
              <a:t>“Use this </a:t>
            </a:r>
            <a:r>
              <a:rPr lang="en-US" b="1" i="1" dirty="0">
                <a:solidFill>
                  <a:prstClr val="white"/>
                </a:solidFill>
              </a:rPr>
              <a:t>Accent Page</a:t>
            </a:r>
            <a:r>
              <a:rPr lang="en-US" i="1" dirty="0">
                <a:solidFill>
                  <a:prstClr val="white"/>
                </a:solidFill>
              </a:rPr>
              <a:t> to place emphasis or call attention to a big statement, message or quote.”</a:t>
            </a:r>
          </a:p>
        </p:txBody>
      </p:sp>
    </p:spTree>
    <p:extLst>
      <p:ext uri="{BB962C8B-B14F-4D97-AF65-F5344CB8AC3E}">
        <p14:creationId xmlns:p14="http://schemas.microsoft.com/office/powerpoint/2010/main" val="153633518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CCENT | PURP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PT_SLIDE_ACCENT_CHOCO_PURPLE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36880" y="0"/>
            <a:ext cx="11297920" cy="5842000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1" spc="0" baseline="0">
                <a:solidFill>
                  <a:schemeClr val="bg1"/>
                </a:solidFill>
              </a:defRPr>
            </a:lvl1pPr>
          </a:lstStyle>
          <a:p>
            <a:r>
              <a:rPr lang="en-US" i="1" dirty="0">
                <a:solidFill>
                  <a:prstClr val="white"/>
                </a:solidFill>
              </a:rPr>
              <a:t>“Use this </a:t>
            </a:r>
            <a:r>
              <a:rPr lang="en-US" b="1" i="1" dirty="0">
                <a:solidFill>
                  <a:prstClr val="white"/>
                </a:solidFill>
              </a:rPr>
              <a:t>Accent Page</a:t>
            </a:r>
            <a:r>
              <a:rPr lang="en-US" i="1" dirty="0">
                <a:solidFill>
                  <a:prstClr val="white"/>
                </a:solidFill>
              </a:rPr>
              <a:t> to place emphasis or call attention to a big statement, message or quote.”</a:t>
            </a:r>
          </a:p>
        </p:txBody>
      </p:sp>
    </p:spTree>
    <p:extLst>
      <p:ext uri="{BB962C8B-B14F-4D97-AF65-F5344CB8AC3E}">
        <p14:creationId xmlns:p14="http://schemas.microsoft.com/office/powerpoint/2010/main" val="1410859929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CCENT | YELLO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PT_SLIDE_ACCENT_CHOCO_YELLOW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36880" y="0"/>
            <a:ext cx="11297920" cy="5842000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1" spc="0" baseline="0">
                <a:solidFill>
                  <a:schemeClr val="bg1"/>
                </a:solidFill>
              </a:defRPr>
            </a:lvl1pPr>
          </a:lstStyle>
          <a:p>
            <a:r>
              <a:rPr lang="en-US" i="1" dirty="0">
                <a:solidFill>
                  <a:prstClr val="white"/>
                </a:solidFill>
              </a:rPr>
              <a:t>“Use this </a:t>
            </a:r>
            <a:r>
              <a:rPr lang="en-US" b="1" i="1" dirty="0">
                <a:solidFill>
                  <a:prstClr val="white"/>
                </a:solidFill>
              </a:rPr>
              <a:t>Accent Page</a:t>
            </a:r>
            <a:r>
              <a:rPr lang="en-US" i="1" dirty="0">
                <a:solidFill>
                  <a:prstClr val="white"/>
                </a:solidFill>
              </a:rPr>
              <a:t> to place emphasis or call attention to a big statement, message or quote.”</a:t>
            </a:r>
          </a:p>
        </p:txBody>
      </p:sp>
    </p:spTree>
    <p:extLst>
      <p:ext uri="{BB962C8B-B14F-4D97-AF65-F5344CB8AC3E}">
        <p14:creationId xmlns:p14="http://schemas.microsoft.com/office/powerpoint/2010/main" val="1410859929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F62738-8DF1-E642-8DCD-13DFB31F6B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FAC1B7-7A7F-244A-985F-8905B0C641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7973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GIR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PT_SLIDE_SECTION_GIRL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235787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BO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PT_SLIDE_SECTION_BOY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4226389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FRIEND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PPT_SLIDE_SECTION_FRIENDS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556765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FAMI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PT_SLIDE_SECTION_FAMILY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1035823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CHOCO HEL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PT_SLIDE_SECTION_CHOCO_HELLO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63513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CHOCO REA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PT_SLIDE_SECTION_CHOCO_READING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1368340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| CHOCO HULA HOOP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PT_SLIDE_SECTION_CHOCO_HULA.png"/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10DF918B-4080-FA48-9965-E73CB50E279F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77520" y="2683169"/>
            <a:ext cx="6373928" cy="1491662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4000" b="0" i="0" spc="600" baseline="0">
                <a:solidFill>
                  <a:srgbClr val="0064A4"/>
                </a:solidFill>
              </a:defRPr>
            </a:lvl1pPr>
          </a:lstStyle>
          <a:p>
            <a:r>
              <a:rPr lang="en-US" dirty="0"/>
              <a:t>SECTION TITLE </a:t>
            </a:r>
            <a:br>
              <a:rPr lang="en-US" dirty="0"/>
            </a:br>
            <a:r>
              <a:rPr lang="en-US" dirty="0"/>
              <a:t>GOES HERE</a:t>
            </a:r>
          </a:p>
        </p:txBody>
      </p:sp>
    </p:spTree>
    <p:extLst>
      <p:ext uri="{BB962C8B-B14F-4D97-AF65-F5344CB8AC3E}">
        <p14:creationId xmlns:p14="http://schemas.microsoft.com/office/powerpoint/2010/main" val="1866291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PT_SLIDE_PAGE_LOGO.png"/>
          <p:cNvPicPr>
            <a:picLocks noChangeAspect="1"/>
          </p:cNvPicPr>
          <p:nvPr userDrawn="1"/>
        </p:nvPicPr>
        <p:blipFill>
          <a:blip r:embed="rId2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A7FD29-E006-CE49-B6BD-67E62A9AF6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EC2067-1A61-0B40-8AA0-8296575997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0036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13E3F4-1214-D44E-9DD0-D9894D3F09B0}"/>
              </a:ext>
            </a:extLst>
          </p:cNvPr>
          <p:cNvSpPr txBox="1"/>
          <p:nvPr userDrawn="1"/>
        </p:nvSpPr>
        <p:spPr>
          <a:xfrm>
            <a:off x="11728508" y="649274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fld id="{D5C8A48B-0E09-AA40-B945-D371BB7E3BDE}" type="slidenum">
              <a:rPr lang="en-US" sz="800" smtClean="0">
                <a:solidFill>
                  <a:srgbClr val="545454"/>
                </a:solidFill>
              </a:rPr>
              <a:t>‹#›</a:t>
            </a:fld>
            <a:endParaRPr lang="en-US" sz="800">
              <a:solidFill>
                <a:srgbClr val="545454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3872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688" r:id="rId2"/>
    <p:sldLayoutId id="2147483702" r:id="rId3"/>
    <p:sldLayoutId id="2147483700" r:id="rId4"/>
    <p:sldLayoutId id="2147483686" r:id="rId5"/>
    <p:sldLayoutId id="2147483701" r:id="rId6"/>
    <p:sldLayoutId id="2147483696" r:id="rId7"/>
    <p:sldLayoutId id="2147483691" r:id="rId8"/>
    <p:sldLayoutId id="2147483697" r:id="rId9"/>
    <p:sldLayoutId id="2147483698" r:id="rId10"/>
    <p:sldLayoutId id="2147483699" r:id="rId11"/>
    <p:sldLayoutId id="2147483650" r:id="rId12"/>
    <p:sldLayoutId id="2147483652" r:id="rId13"/>
    <p:sldLayoutId id="2147483679" r:id="rId14"/>
    <p:sldLayoutId id="2147483657" r:id="rId15"/>
    <p:sldLayoutId id="2147483683" r:id="rId16"/>
    <p:sldLayoutId id="2147483654" r:id="rId17"/>
    <p:sldLayoutId id="2147483655" r:id="rId18"/>
    <p:sldLayoutId id="2147483680" r:id="rId19"/>
    <p:sldLayoutId id="2147483709" r:id="rId20"/>
    <p:sldLayoutId id="2147483710" r:id="rId21"/>
    <p:sldLayoutId id="2147483704" r:id="rId22"/>
    <p:sldLayoutId id="2147483705" r:id="rId23"/>
    <p:sldLayoutId id="2147483706" r:id="rId24"/>
    <p:sldLayoutId id="2147483707" r:id="rId25"/>
    <p:sldLayoutId id="2147483708" r:id="rId26"/>
    <p:sldLayoutId id="2147483712" r:id="rId27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rgbClr val="0064A4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spcAft>
          <a:spcPts val="600"/>
        </a:spcAft>
        <a:buFont typeface="Arial" panose="020B0604020202020204" pitchFamily="34" charset="0"/>
        <a:buChar char="•"/>
        <a:defRPr sz="2800" kern="1200">
          <a:solidFill>
            <a:srgbClr val="767679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spcAft>
          <a:spcPts val="600"/>
        </a:spcAft>
        <a:buFont typeface="Arial" panose="020B0604020202020204" pitchFamily="34" charset="0"/>
        <a:buChar char="•"/>
        <a:defRPr sz="2400" kern="1200">
          <a:solidFill>
            <a:srgbClr val="767679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spcAft>
          <a:spcPts val="600"/>
        </a:spcAft>
        <a:buFont typeface="Arial" panose="020B0604020202020204" pitchFamily="34" charset="0"/>
        <a:buChar char="•"/>
        <a:defRPr sz="2000" kern="1200">
          <a:solidFill>
            <a:srgbClr val="767679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spcAft>
          <a:spcPts val="600"/>
        </a:spcAft>
        <a:buFont typeface="Arial" panose="020B0604020202020204" pitchFamily="34" charset="0"/>
        <a:buChar char="•"/>
        <a:defRPr sz="1800" kern="1200">
          <a:solidFill>
            <a:srgbClr val="767679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spcAft>
          <a:spcPts val="600"/>
        </a:spcAft>
        <a:buFont typeface="Arial" panose="020B0604020202020204" pitchFamily="34" charset="0"/>
        <a:buChar char="•"/>
        <a:defRPr sz="1800" kern="1200">
          <a:solidFill>
            <a:srgbClr val="767679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jpeg"/><Relationship Id="rId7" Type="http://schemas.openxmlformats.org/officeDocument/2006/relationships/image" Target="../media/image25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jpeg"/><Relationship Id="rId5" Type="http://schemas.openxmlformats.org/officeDocument/2006/relationships/image" Target="../media/image23.jpeg"/><Relationship Id="rId4" Type="http://schemas.openxmlformats.org/officeDocument/2006/relationships/image" Target="../media/image22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9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3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9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9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3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7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9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9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9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59812" y="4007830"/>
            <a:ext cx="6725920" cy="701822"/>
          </a:xfrm>
        </p:spPr>
        <p:txBody>
          <a:bodyPr>
            <a:normAutofit/>
          </a:bodyPr>
          <a:lstStyle/>
          <a:p>
            <a:r>
              <a:rPr lang="en-US" sz="3200" dirty="0"/>
              <a:t>Child Abuse and Maltreatment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20720" y="2301994"/>
            <a:ext cx="6725920" cy="1096351"/>
          </a:xfrm>
        </p:spPr>
        <p:txBody>
          <a:bodyPr/>
          <a:lstStyle/>
          <a:p>
            <a:r>
              <a:rPr lang="en-US" sz="4800" dirty="0"/>
              <a:t>Fire Department EMT Skills</a:t>
            </a:r>
          </a:p>
        </p:txBody>
      </p:sp>
      <p:pic>
        <p:nvPicPr>
          <p:cNvPr id="10" name="Picture 9" descr="GettyImages-517675430.jpg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" y="5207691"/>
            <a:ext cx="4866998" cy="1650308"/>
          </a:xfrm>
          <a:prstGeom prst="rect">
            <a:avLst/>
          </a:prstGeom>
        </p:spPr>
      </p:pic>
      <p:pic>
        <p:nvPicPr>
          <p:cNvPr id="13" name="Picture 12" descr="GettyImages-900404684.jpg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564881" y="5207691"/>
            <a:ext cx="3627120" cy="1650309"/>
          </a:xfrm>
          <a:prstGeom prst="rect">
            <a:avLst/>
          </a:prstGeom>
        </p:spPr>
      </p:pic>
      <p:pic>
        <p:nvPicPr>
          <p:cNvPr id="15" name="Picture 14" descr="shutterstock_433871116_1000x667_Medium.jpg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46320" y="5200904"/>
            <a:ext cx="3738880" cy="1657096"/>
          </a:xfrm>
          <a:prstGeom prst="rect">
            <a:avLst/>
          </a:prstGeom>
        </p:spPr>
      </p:pic>
      <p:pic>
        <p:nvPicPr>
          <p:cNvPr id="16" name="Picture 15" descr="GettyImages-1033766346.jpg"/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10560" y="0"/>
            <a:ext cx="4368800" cy="1645920"/>
          </a:xfrm>
          <a:prstGeom prst="rect">
            <a:avLst/>
          </a:prstGeom>
        </p:spPr>
      </p:pic>
      <p:pic>
        <p:nvPicPr>
          <p:cNvPr id="18" name="Picture 17" descr="GettyImages-856561330.jpg"/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0"/>
            <a:ext cx="3220720" cy="1656080"/>
          </a:xfrm>
          <a:prstGeom prst="rect">
            <a:avLst/>
          </a:prstGeom>
        </p:spPr>
      </p:pic>
      <p:pic>
        <p:nvPicPr>
          <p:cNvPr id="22" name="Picture 21" descr="GettyImages-86207344.jpg"/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79464" y="0"/>
            <a:ext cx="4612536" cy="1656080"/>
          </a:xfrm>
          <a:prstGeom prst="rect">
            <a:avLst/>
          </a:prstGeom>
        </p:spPr>
      </p:pic>
      <p:pic>
        <p:nvPicPr>
          <p:cNvPr id="4" name="Picture 8">
            <a:extLst>
              <a:ext uri="{FF2B5EF4-FFF2-40B4-BE49-F238E27FC236}">
                <a16:creationId xmlns:a16="http://schemas.microsoft.com/office/drawing/2014/main" id="{CB6DF81B-BD64-06A8-BFEF-EABB25E45C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43032" y="6254496"/>
            <a:ext cx="146208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550A827-DE39-4AF5-7736-E0AC75A20E15}"/>
              </a:ext>
            </a:extLst>
          </p:cNvPr>
          <p:cNvSpPr txBox="1"/>
          <p:nvPr/>
        </p:nvSpPr>
        <p:spPr>
          <a:xfrm>
            <a:off x="3210560" y="4531773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Escape Room Debrief</a:t>
            </a:r>
          </a:p>
        </p:txBody>
      </p:sp>
    </p:spTree>
    <p:extLst>
      <p:ext uri="{BB962C8B-B14F-4D97-AF65-F5344CB8AC3E}">
        <p14:creationId xmlns:p14="http://schemas.microsoft.com/office/powerpoint/2010/main" val="17221821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8466715C-6510-4A5E-9F3A-432D7ABF653B}"/>
              </a:ext>
            </a:extLst>
          </p:cNvPr>
          <p:cNvSpPr/>
          <p:nvPr/>
        </p:nvSpPr>
        <p:spPr>
          <a:xfrm>
            <a:off x="365201" y="533300"/>
            <a:ext cx="4493539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ase #6: Kyle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9B9F66BC-2C0C-462C-9DFD-C5E25D9AFB45}"/>
              </a:ext>
            </a:extLst>
          </p:cNvPr>
          <p:cNvSpPr/>
          <p:nvPr/>
        </p:nvSpPr>
        <p:spPr>
          <a:xfrm>
            <a:off x="3891516" y="4786949"/>
            <a:ext cx="7532421" cy="1796903"/>
          </a:xfrm>
          <a:prstGeom prst="roundRect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.   Kyle: What puts children less than a year old at the highest risk for abuse?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y are totally dependent on parents for survival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y walk/run too much for some parents to keep up with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y are unable to defend themselves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y are unable to communicate</a:t>
            </a:r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191078DA-B533-4DA8-8C1E-A077A1930271}"/>
              </a:ext>
            </a:extLst>
          </p:cNvPr>
          <p:cNvSpPr/>
          <p:nvPr/>
        </p:nvSpPr>
        <p:spPr>
          <a:xfrm>
            <a:off x="4462943" y="5347610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6633C66E-1FD8-4763-8707-9F281D148452}"/>
              </a:ext>
            </a:extLst>
          </p:cNvPr>
          <p:cNvSpPr/>
          <p:nvPr/>
        </p:nvSpPr>
        <p:spPr>
          <a:xfrm>
            <a:off x="4462943" y="5863035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21925C41-422F-4DF9-9081-6A19CF02772F}"/>
              </a:ext>
            </a:extLst>
          </p:cNvPr>
          <p:cNvSpPr/>
          <p:nvPr/>
        </p:nvSpPr>
        <p:spPr>
          <a:xfrm>
            <a:off x="4462943" y="6108343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046AE320-8D89-40F5-9EA8-6397F358C6E3}"/>
              </a:ext>
            </a:extLst>
          </p:cNvPr>
          <p:cNvGrpSpPr/>
          <p:nvPr/>
        </p:nvGrpSpPr>
        <p:grpSpPr>
          <a:xfrm>
            <a:off x="371475" y="1676514"/>
            <a:ext cx="11449050" cy="3019425"/>
            <a:chOff x="371475" y="1919287"/>
            <a:chExt cx="11449050" cy="301942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03B3DB8-FF0A-4D50-9B17-79A0455CAA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1475" y="1919287"/>
              <a:ext cx="11449050" cy="3019425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13828ADA-9CB8-443A-9FF9-0F109BF0F53A}"/>
                </a:ext>
              </a:extLst>
            </p:cNvPr>
            <p:cNvSpPr/>
            <p:nvPr/>
          </p:nvSpPr>
          <p:spPr>
            <a:xfrm>
              <a:off x="371475" y="2714017"/>
              <a:ext cx="221912" cy="189448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6180891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0128" y="2122129"/>
            <a:ext cx="10951743" cy="2613741"/>
          </a:xfrm>
        </p:spPr>
        <p:txBody>
          <a:bodyPr/>
          <a:lstStyle/>
          <a:p>
            <a:pPr algn="ctr"/>
            <a:r>
              <a:rPr lang="en-US" sz="6600" b="1" i="0" dirty="0"/>
              <a:t>Reporting Requirements Review…</a:t>
            </a:r>
            <a:br>
              <a:rPr lang="en-US" i="0" spc="600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65601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5128A-9B64-46AA-8D06-3B805D19E5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-202361"/>
            <a:ext cx="10515600" cy="1325563"/>
          </a:xfrm>
        </p:spPr>
        <p:txBody>
          <a:bodyPr/>
          <a:lstStyle/>
          <a:p>
            <a:r>
              <a:rPr lang="en-US" dirty="0"/>
              <a:t>Making a Report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E403139-601F-462C-B5CC-9FE370F156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2527" y="912530"/>
            <a:ext cx="7232534" cy="5660244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471608D2-CC43-4B53-80A3-948CF697B09F}"/>
              </a:ext>
            </a:extLst>
          </p:cNvPr>
          <p:cNvSpPr/>
          <p:nvPr/>
        </p:nvSpPr>
        <p:spPr>
          <a:xfrm>
            <a:off x="1954635" y="912530"/>
            <a:ext cx="7675926" cy="110921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We used our County EMS Policy here to discuss reporting requirements</a:t>
            </a:r>
          </a:p>
        </p:txBody>
      </p:sp>
    </p:spTree>
    <p:extLst>
      <p:ext uri="{BB962C8B-B14F-4D97-AF65-F5344CB8AC3E}">
        <p14:creationId xmlns:p14="http://schemas.microsoft.com/office/powerpoint/2010/main" val="148592148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E78DD16-DFA7-47BC-859B-DCBEA28C93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9325" y="1014412"/>
            <a:ext cx="7753350" cy="482917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360E42C5-6E0A-4A03-9289-E7ECCC1407D2}"/>
              </a:ext>
            </a:extLst>
          </p:cNvPr>
          <p:cNvSpPr/>
          <p:nvPr/>
        </p:nvSpPr>
        <p:spPr>
          <a:xfrm>
            <a:off x="2219325" y="5595457"/>
            <a:ext cx="1840947" cy="2481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740C837-CDB4-45C7-A1EF-99F2BB8F0CF6}"/>
              </a:ext>
            </a:extLst>
          </p:cNvPr>
          <p:cNvSpPr/>
          <p:nvPr/>
        </p:nvSpPr>
        <p:spPr>
          <a:xfrm>
            <a:off x="6308521" y="2281806"/>
            <a:ext cx="738231" cy="1845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12812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32A4B40-06DA-4705-B3AC-275686AA27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7362" y="1085850"/>
            <a:ext cx="8677275" cy="46863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B06B683E-D904-409C-9A01-DB717F8231F7}"/>
              </a:ext>
            </a:extLst>
          </p:cNvPr>
          <p:cNvSpPr/>
          <p:nvPr/>
        </p:nvSpPr>
        <p:spPr>
          <a:xfrm>
            <a:off x="1493240" y="1085850"/>
            <a:ext cx="8941397" cy="7261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56B425A-0F9E-434C-94B9-19F2FC54F7BB}"/>
              </a:ext>
            </a:extLst>
          </p:cNvPr>
          <p:cNvSpPr/>
          <p:nvPr/>
        </p:nvSpPr>
        <p:spPr>
          <a:xfrm>
            <a:off x="1677798" y="1661020"/>
            <a:ext cx="864066" cy="46978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8ED5925-BA88-4F89-B0FC-CCC066EEF145}"/>
              </a:ext>
            </a:extLst>
          </p:cNvPr>
          <p:cNvSpPr/>
          <p:nvPr/>
        </p:nvSpPr>
        <p:spPr>
          <a:xfrm>
            <a:off x="9570571" y="1736521"/>
            <a:ext cx="864066" cy="46978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2D9FAFA-5982-4822-8872-4982F95302E8}"/>
              </a:ext>
            </a:extLst>
          </p:cNvPr>
          <p:cNvSpPr/>
          <p:nvPr/>
        </p:nvSpPr>
        <p:spPr>
          <a:xfrm>
            <a:off x="7786381" y="2501317"/>
            <a:ext cx="728445" cy="1579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7603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0128" y="2122129"/>
            <a:ext cx="10951743" cy="2613741"/>
          </a:xfrm>
        </p:spPr>
        <p:txBody>
          <a:bodyPr/>
          <a:lstStyle/>
          <a:p>
            <a:pPr algn="ctr"/>
            <a:r>
              <a:rPr lang="en-US" sz="6600" b="1" i="0" dirty="0"/>
              <a:t>Policy Review…</a:t>
            </a:r>
            <a:br>
              <a:rPr lang="en-US" i="0" spc="600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944343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90723AF6-5347-47C1-B73F-02387C5E9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1866" y="-180159"/>
            <a:ext cx="11368267" cy="1325563"/>
          </a:xfrm>
        </p:spPr>
        <p:txBody>
          <a:bodyPr/>
          <a:lstStyle/>
          <a:p>
            <a:r>
              <a:rPr lang="en-US" dirty="0"/>
              <a:t>When to make Base Contact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9145FA7-F0B4-4522-A9D5-B317AB194A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8047" y="1080236"/>
            <a:ext cx="10435904" cy="165377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F9C92F2-19FA-4A55-BCD1-0190E2C796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8687" y="3205162"/>
            <a:ext cx="10334625" cy="44767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85EB6CC-29E2-4D26-BEFB-61A6F6455D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71824" y="4200962"/>
            <a:ext cx="5848350" cy="4191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270CF49A-F7C8-4B21-A644-F2DBAFF6BA98}"/>
              </a:ext>
            </a:extLst>
          </p:cNvPr>
          <p:cNvSpPr/>
          <p:nvPr/>
        </p:nvSpPr>
        <p:spPr>
          <a:xfrm>
            <a:off x="704675" y="1061943"/>
            <a:ext cx="10609275" cy="106886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We used our County EMS Policy here to discuss accessing online medical control for suspected abuse patients</a:t>
            </a:r>
          </a:p>
        </p:txBody>
      </p:sp>
    </p:spTree>
    <p:extLst>
      <p:ext uri="{BB962C8B-B14F-4D97-AF65-F5344CB8AC3E}">
        <p14:creationId xmlns:p14="http://schemas.microsoft.com/office/powerpoint/2010/main" val="41242433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0128" y="2122129"/>
            <a:ext cx="10951743" cy="2613741"/>
          </a:xfrm>
        </p:spPr>
        <p:txBody>
          <a:bodyPr/>
          <a:lstStyle/>
          <a:p>
            <a:pPr algn="ctr"/>
            <a:r>
              <a:rPr lang="en-US" sz="6600" b="1" i="0" dirty="0"/>
              <a:t>Escape Room Debrief – let’s talk about it…</a:t>
            </a:r>
            <a:br>
              <a:rPr lang="en-US" i="0" spc="600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72888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C96A113-A239-42AE-BFDF-03C6DEC9D7CF}"/>
              </a:ext>
            </a:extLst>
          </p:cNvPr>
          <p:cNvSpPr txBox="1"/>
          <p:nvPr/>
        </p:nvSpPr>
        <p:spPr>
          <a:xfrm>
            <a:off x="931817" y="1454331"/>
            <a:ext cx="11129554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4000" dirty="0">
                <a:solidFill>
                  <a:schemeClr val="bg1"/>
                </a:solidFill>
                <a:latin typeface="Arial Nova" panose="020B0504020202020204" pitchFamily="34" charset="0"/>
              </a:rPr>
              <a:t>Describe your experience with this escape room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4000" dirty="0">
                <a:solidFill>
                  <a:schemeClr val="bg1"/>
                </a:solidFill>
                <a:latin typeface="Arial Nova" panose="020B0504020202020204" pitchFamily="34" charset="0"/>
              </a:rPr>
              <a:t>Good/bad/what did you like/not like? 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4000" dirty="0">
                <a:solidFill>
                  <a:schemeClr val="bg1"/>
                </a:solidFill>
                <a:latin typeface="Arial Nova" panose="020B0504020202020204" pitchFamily="34" charset="0"/>
              </a:rPr>
              <a:t>What made your team successful or unsuccessful?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4000" dirty="0">
                <a:solidFill>
                  <a:schemeClr val="bg1"/>
                </a:solidFill>
                <a:latin typeface="Arial Nova" panose="020B0504020202020204" pitchFamily="34" charset="0"/>
              </a:rPr>
              <a:t>Describe one thing you learnt from this experience?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4000" dirty="0">
                <a:solidFill>
                  <a:schemeClr val="bg1"/>
                </a:solidFill>
                <a:latin typeface="Arial Nova" panose="020B0504020202020204" pitchFamily="34" charset="0"/>
              </a:rPr>
              <a:t>Who was the rock star of your team?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F3A6F0F-E93D-4E24-8270-C60527E685E6}"/>
              </a:ext>
            </a:extLst>
          </p:cNvPr>
          <p:cNvSpPr txBox="1"/>
          <p:nvPr/>
        </p:nvSpPr>
        <p:spPr>
          <a:xfrm>
            <a:off x="522514" y="181094"/>
            <a:ext cx="8817428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000" b="1" i="0" dirty="0">
                <a:solidFill>
                  <a:schemeClr val="bg1"/>
                </a:solidFill>
                <a:latin typeface="Arial Nova" panose="020B0504020202020204" pitchFamily="34" charset="0"/>
              </a:rPr>
              <a:t>Conversation starters… </a:t>
            </a:r>
            <a:endParaRPr lang="en-US" sz="6000" dirty="0">
              <a:solidFill>
                <a:schemeClr val="bg1"/>
              </a:solidFill>
              <a:latin typeface="Arial Nova" panose="020B05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07211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0128" y="2122129"/>
            <a:ext cx="10951743" cy="2613741"/>
          </a:xfrm>
        </p:spPr>
        <p:txBody>
          <a:bodyPr/>
          <a:lstStyle/>
          <a:p>
            <a:pPr algn="ctr"/>
            <a:r>
              <a:rPr lang="en-US" sz="6600" b="1" i="0" dirty="0"/>
              <a:t>Quick Case Study Review…</a:t>
            </a:r>
            <a:br>
              <a:rPr lang="en-US" i="0" spc="600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26860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A3E1769-AB22-4700-A4E2-D3CCF8D7155C}"/>
              </a:ext>
            </a:extLst>
          </p:cNvPr>
          <p:cNvSpPr/>
          <p:nvPr/>
        </p:nvSpPr>
        <p:spPr>
          <a:xfrm>
            <a:off x="248983" y="88882"/>
            <a:ext cx="5147564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ase #1: Jimmy</a:t>
            </a: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0D25330D-F547-49E8-AD5E-B726865D41AF}"/>
              </a:ext>
            </a:extLst>
          </p:cNvPr>
          <p:cNvSpPr/>
          <p:nvPr/>
        </p:nvSpPr>
        <p:spPr>
          <a:xfrm>
            <a:off x="6988029" y="4924338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34EFF2BF-9939-4B6C-9BE6-3DA926880119}"/>
              </a:ext>
            </a:extLst>
          </p:cNvPr>
          <p:cNvSpPr/>
          <p:nvPr/>
        </p:nvSpPr>
        <p:spPr>
          <a:xfrm>
            <a:off x="6988029" y="5470560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0EEC623-3ED7-4DDC-88A8-97FFC4F6785A}"/>
              </a:ext>
            </a:extLst>
          </p:cNvPr>
          <p:cNvGrpSpPr/>
          <p:nvPr/>
        </p:nvGrpSpPr>
        <p:grpSpPr>
          <a:xfrm>
            <a:off x="610094" y="1365372"/>
            <a:ext cx="8763000" cy="4210050"/>
            <a:chOff x="1714500" y="1323975"/>
            <a:chExt cx="8763000" cy="4210050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B14F624-4059-476A-8487-F2C58E67985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14500" y="1323975"/>
              <a:ext cx="8763000" cy="4210050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3CA031EC-58B0-4206-A530-37EE78413770}"/>
                </a:ext>
              </a:extLst>
            </p:cNvPr>
            <p:cNvSpPr/>
            <p:nvPr/>
          </p:nvSpPr>
          <p:spPr>
            <a:xfrm>
              <a:off x="6831622" y="5222630"/>
              <a:ext cx="1222131" cy="193432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2A3AA74F-1BA4-4B65-BEA4-5D0EE08B7370}"/>
                </a:ext>
              </a:extLst>
            </p:cNvPr>
            <p:cNvSpPr/>
            <p:nvPr/>
          </p:nvSpPr>
          <p:spPr>
            <a:xfrm>
              <a:off x="2910254" y="3974123"/>
              <a:ext cx="571500" cy="140677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18AF2B35-9591-4CF0-95BF-DE4F862F2CD8}"/>
              </a:ext>
            </a:extLst>
          </p:cNvPr>
          <p:cNvSpPr/>
          <p:nvPr/>
        </p:nvSpPr>
        <p:spPr>
          <a:xfrm>
            <a:off x="6408914" y="4372280"/>
            <a:ext cx="5727405" cy="1796903"/>
          </a:xfrm>
          <a:prstGeom prst="roundRect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marL="342900" marR="0" lvl="0" indent="-3429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immy: What is concerning about this case?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certainty of how the baby fell from the bed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thing, the injury is consistent with the history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grandmother left the patient with other minors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ent was “crying hysterically”</a:t>
            </a:r>
          </a:p>
        </p:txBody>
      </p:sp>
    </p:spTree>
    <p:extLst>
      <p:ext uri="{BB962C8B-B14F-4D97-AF65-F5344CB8AC3E}">
        <p14:creationId xmlns:p14="http://schemas.microsoft.com/office/powerpoint/2010/main" val="1323247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97F429D3-5935-4A23-979E-3A3DC979B50B}"/>
              </a:ext>
            </a:extLst>
          </p:cNvPr>
          <p:cNvSpPr/>
          <p:nvPr/>
        </p:nvSpPr>
        <p:spPr>
          <a:xfrm>
            <a:off x="150122" y="155862"/>
            <a:ext cx="4339651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ase #2: Kim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BA039099-739C-4FAA-B109-8E070A2860A9}"/>
              </a:ext>
            </a:extLst>
          </p:cNvPr>
          <p:cNvSpPr/>
          <p:nvPr/>
        </p:nvSpPr>
        <p:spPr>
          <a:xfrm>
            <a:off x="5611472" y="4994958"/>
            <a:ext cx="5727405" cy="1796903"/>
          </a:xfrm>
          <a:prstGeom prst="roundRect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.   Kim: what types of abuse did this patient experience?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lect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sical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otional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xual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9C588AAD-3C7B-47FD-BECD-B9012F2153E5}"/>
              </a:ext>
            </a:extLst>
          </p:cNvPr>
          <p:cNvSpPr/>
          <p:nvPr/>
        </p:nvSpPr>
        <p:spPr>
          <a:xfrm>
            <a:off x="6191075" y="5537719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F9794197-D40B-4E23-94AA-14BA18B30BFC}"/>
              </a:ext>
            </a:extLst>
          </p:cNvPr>
          <p:cNvSpPr/>
          <p:nvPr/>
        </p:nvSpPr>
        <p:spPr>
          <a:xfrm>
            <a:off x="6191075" y="5788547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704CB895-0266-4903-B607-C276FAAEA887}"/>
              </a:ext>
            </a:extLst>
          </p:cNvPr>
          <p:cNvSpPr/>
          <p:nvPr/>
        </p:nvSpPr>
        <p:spPr>
          <a:xfrm>
            <a:off x="6191075" y="6080480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4CBA067-9251-4526-AF19-FAF9C6C819F9}"/>
              </a:ext>
            </a:extLst>
          </p:cNvPr>
          <p:cNvGrpSpPr/>
          <p:nvPr/>
        </p:nvGrpSpPr>
        <p:grpSpPr>
          <a:xfrm>
            <a:off x="342900" y="1251633"/>
            <a:ext cx="11506200" cy="3743325"/>
            <a:chOff x="342900" y="1557337"/>
            <a:chExt cx="11506200" cy="3743325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FE416FE8-4EFE-43FF-BDC3-CCD5F6B572B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2900" y="1557337"/>
              <a:ext cx="11506200" cy="3743325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2CA3C16C-5B87-4491-8F9D-AE58F43F7C62}"/>
                </a:ext>
              </a:extLst>
            </p:cNvPr>
            <p:cNvSpPr/>
            <p:nvPr/>
          </p:nvSpPr>
          <p:spPr>
            <a:xfrm>
              <a:off x="2733472" y="3978613"/>
              <a:ext cx="544749" cy="175098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BD801FBF-6FF3-4A02-8633-C1B97A718094}"/>
                </a:ext>
              </a:extLst>
            </p:cNvPr>
            <p:cNvSpPr/>
            <p:nvPr/>
          </p:nvSpPr>
          <p:spPr>
            <a:xfrm>
              <a:off x="2273029" y="4322629"/>
              <a:ext cx="781456" cy="175098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B1F4BCE0-0550-444C-8691-022AFA729B06}"/>
                </a:ext>
              </a:extLst>
            </p:cNvPr>
            <p:cNvSpPr/>
            <p:nvPr/>
          </p:nvSpPr>
          <p:spPr>
            <a:xfrm>
              <a:off x="8255540" y="4675761"/>
              <a:ext cx="781456" cy="197795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852BEC92-5451-457F-9478-70C950633FEE}"/>
                </a:ext>
              </a:extLst>
            </p:cNvPr>
            <p:cNvSpPr/>
            <p:nvPr/>
          </p:nvSpPr>
          <p:spPr>
            <a:xfrm>
              <a:off x="11118715" y="1669915"/>
              <a:ext cx="194554" cy="178340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9405564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B0AE696F-1663-427C-9B6A-7F3CF6781380}"/>
              </a:ext>
            </a:extLst>
          </p:cNvPr>
          <p:cNvGrpSpPr/>
          <p:nvPr/>
        </p:nvGrpSpPr>
        <p:grpSpPr>
          <a:xfrm>
            <a:off x="2558642" y="547502"/>
            <a:ext cx="8911469" cy="4297630"/>
            <a:chOff x="1214437" y="1390650"/>
            <a:chExt cx="9763125" cy="462915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61C9B8A-BA74-4CBF-B7FB-431884CED8D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14437" y="1390650"/>
              <a:ext cx="9763125" cy="4629150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20BAD1B-BEF5-435E-8010-9E5DE833B2B5}"/>
                </a:ext>
              </a:extLst>
            </p:cNvPr>
            <p:cNvSpPr/>
            <p:nvPr/>
          </p:nvSpPr>
          <p:spPr>
            <a:xfrm>
              <a:off x="7324928" y="1488332"/>
              <a:ext cx="612842" cy="145915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5DCF78E7-F6DC-4375-A568-EE4941E375B6}"/>
                </a:ext>
              </a:extLst>
            </p:cNvPr>
            <p:cNvSpPr/>
            <p:nvPr/>
          </p:nvSpPr>
          <p:spPr>
            <a:xfrm>
              <a:off x="5383492" y="3439133"/>
              <a:ext cx="712508" cy="150373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3D18C02B-2E65-46AC-B633-39691C25BB9F}"/>
                </a:ext>
              </a:extLst>
            </p:cNvPr>
            <p:cNvSpPr/>
            <p:nvPr/>
          </p:nvSpPr>
          <p:spPr>
            <a:xfrm>
              <a:off x="4218562" y="3751634"/>
              <a:ext cx="460442" cy="149157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DE0C68FF-0AAC-4E57-9777-B1E4F0B2553D}"/>
                </a:ext>
              </a:extLst>
            </p:cNvPr>
            <p:cNvSpPr/>
            <p:nvPr/>
          </p:nvSpPr>
          <p:spPr>
            <a:xfrm>
              <a:off x="2568103" y="4597941"/>
              <a:ext cx="797668" cy="149158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B43DDB04-F0E3-4735-ACD2-851DF7B72B9C}"/>
                </a:ext>
              </a:extLst>
            </p:cNvPr>
            <p:cNvSpPr/>
            <p:nvPr/>
          </p:nvSpPr>
          <p:spPr>
            <a:xfrm>
              <a:off x="6558824" y="4601590"/>
              <a:ext cx="406180" cy="145509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4F8F78E0-1CCF-48BD-BAD7-7023EB5D6E3F}"/>
                </a:ext>
              </a:extLst>
            </p:cNvPr>
            <p:cNvSpPr/>
            <p:nvPr/>
          </p:nvSpPr>
          <p:spPr>
            <a:xfrm>
              <a:off x="2568103" y="5464108"/>
              <a:ext cx="749029" cy="149158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1C1B2D7D-4E32-46E1-9C38-B28FCF3DAD23}"/>
                </a:ext>
              </a:extLst>
            </p:cNvPr>
            <p:cNvSpPr/>
            <p:nvPr/>
          </p:nvSpPr>
          <p:spPr>
            <a:xfrm>
              <a:off x="8926749" y="4043464"/>
              <a:ext cx="1160833" cy="149157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CEE8C3C3-804A-4329-8C1E-EB8DAABD35AA}"/>
              </a:ext>
            </a:extLst>
          </p:cNvPr>
          <p:cNvSpPr/>
          <p:nvPr/>
        </p:nvSpPr>
        <p:spPr>
          <a:xfrm>
            <a:off x="226391" y="975363"/>
            <a:ext cx="2944321" cy="1754326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ase #3: Jack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CF9ECBD7-52EE-47F8-8393-41463ED1B0B4}"/>
              </a:ext>
            </a:extLst>
          </p:cNvPr>
          <p:cNvSpPr/>
          <p:nvPr/>
        </p:nvSpPr>
        <p:spPr>
          <a:xfrm>
            <a:off x="1998921" y="5337544"/>
            <a:ext cx="8244803" cy="1375440"/>
          </a:xfrm>
          <a:prstGeom prst="roundRect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.    Jack: Does this call meet CCERC base contact criteria?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s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41007E8C-012B-40B4-8D90-5AE861567FAA}"/>
              </a:ext>
            </a:extLst>
          </p:cNvPr>
          <p:cNvSpPr/>
          <p:nvPr/>
        </p:nvSpPr>
        <p:spPr>
          <a:xfrm>
            <a:off x="2558642" y="5920402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5920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6259E46-70C8-455E-8A35-FDC8859BC541}"/>
              </a:ext>
            </a:extLst>
          </p:cNvPr>
          <p:cNvSpPr/>
          <p:nvPr/>
        </p:nvSpPr>
        <p:spPr>
          <a:xfrm>
            <a:off x="77362" y="614000"/>
            <a:ext cx="5109092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ase #4: Poppy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C81A3E9F-6DEB-46E9-ABE5-F772DD097733}"/>
              </a:ext>
            </a:extLst>
          </p:cNvPr>
          <p:cNvSpPr/>
          <p:nvPr/>
        </p:nvSpPr>
        <p:spPr>
          <a:xfrm>
            <a:off x="5398821" y="5159090"/>
            <a:ext cx="6201300" cy="1188548"/>
          </a:xfrm>
          <a:prstGeom prst="roundRect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.   Poppy: Does this case raise your suspicion for abuse or neglect?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s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8C5940A-0AF5-4895-B679-6035D87A96E9}"/>
              </a:ext>
            </a:extLst>
          </p:cNvPr>
          <p:cNvSpPr/>
          <p:nvPr/>
        </p:nvSpPr>
        <p:spPr>
          <a:xfrm>
            <a:off x="5978554" y="5648502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E7006056-FA35-43DA-84EE-30A05DB04B1B}"/>
              </a:ext>
            </a:extLst>
          </p:cNvPr>
          <p:cNvGrpSpPr/>
          <p:nvPr/>
        </p:nvGrpSpPr>
        <p:grpSpPr>
          <a:xfrm>
            <a:off x="204787" y="2005012"/>
            <a:ext cx="11782425" cy="2847975"/>
            <a:chOff x="204787" y="2005012"/>
            <a:chExt cx="11782425" cy="2847975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21093C4-AB54-4C8B-B245-AA0441B145D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4787" y="2005012"/>
              <a:ext cx="11782425" cy="2847975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0FCC0F1B-8B6D-4865-AB09-EDFA1BE2D55A}"/>
                </a:ext>
              </a:extLst>
            </p:cNvPr>
            <p:cNvSpPr/>
            <p:nvPr/>
          </p:nvSpPr>
          <p:spPr>
            <a:xfrm>
              <a:off x="1867711" y="2106444"/>
              <a:ext cx="1465634" cy="140646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46D7BBA4-EA58-4EA9-8005-260E8AAB8907}"/>
                </a:ext>
              </a:extLst>
            </p:cNvPr>
            <p:cNvSpPr/>
            <p:nvPr/>
          </p:nvSpPr>
          <p:spPr>
            <a:xfrm>
              <a:off x="5739745" y="2106444"/>
              <a:ext cx="712508" cy="150373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A1708844-B9F1-4304-A6BF-0AE8150F99EA}"/>
                </a:ext>
              </a:extLst>
            </p:cNvPr>
            <p:cNvSpPr/>
            <p:nvPr/>
          </p:nvSpPr>
          <p:spPr>
            <a:xfrm>
              <a:off x="3690879" y="4227074"/>
              <a:ext cx="589291" cy="140645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5D977EEA-8DB8-4D96-A728-11FDB113D3E4}"/>
                </a:ext>
              </a:extLst>
            </p:cNvPr>
            <p:cNvSpPr/>
            <p:nvPr/>
          </p:nvSpPr>
          <p:spPr>
            <a:xfrm>
              <a:off x="8389339" y="4217346"/>
              <a:ext cx="712508" cy="150373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220150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63A8785C-D728-4118-9521-6D0B7911A4B1}"/>
              </a:ext>
            </a:extLst>
          </p:cNvPr>
          <p:cNvSpPr/>
          <p:nvPr/>
        </p:nvSpPr>
        <p:spPr>
          <a:xfrm>
            <a:off x="71812" y="443084"/>
            <a:ext cx="6032421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ase # 5: Precious</a:t>
            </a:r>
            <a:endParaRPr lang="en-US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B4FF7E7B-6A57-4C1A-AD1D-CB413459E6D0}"/>
              </a:ext>
            </a:extLst>
          </p:cNvPr>
          <p:cNvSpPr/>
          <p:nvPr/>
        </p:nvSpPr>
        <p:spPr>
          <a:xfrm>
            <a:off x="479723" y="4085227"/>
            <a:ext cx="11232552" cy="1796903"/>
          </a:xfrm>
          <a:prstGeom prst="roundRect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.  Precious: If you leave a child with PD, does that relieve you of your duty to file a child abuse report with CPS?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s</a:t>
            </a:r>
          </a:p>
          <a:p>
            <a:pPr marL="742950" marR="0" lvl="1" indent="-28575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Font typeface="+mj-lt"/>
              <a:buAutoNum type="alphaLcPeriod"/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</a:t>
            </a:r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CDF19389-FC43-4B53-9F85-E862578D97AF}"/>
              </a:ext>
            </a:extLst>
          </p:cNvPr>
          <p:cNvSpPr/>
          <p:nvPr/>
        </p:nvSpPr>
        <p:spPr>
          <a:xfrm>
            <a:off x="1040235" y="5180382"/>
            <a:ext cx="234892" cy="2097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4A18A7FA-C8A9-4A8E-A6D2-C257923A69E0}"/>
              </a:ext>
            </a:extLst>
          </p:cNvPr>
          <p:cNvGrpSpPr/>
          <p:nvPr/>
        </p:nvGrpSpPr>
        <p:grpSpPr>
          <a:xfrm>
            <a:off x="193970" y="1612003"/>
            <a:ext cx="11820525" cy="1981200"/>
            <a:chOff x="185737" y="2438400"/>
            <a:chExt cx="11820525" cy="19812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135F79D-BA9A-42FE-951F-5211AE034E1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5737" y="2438400"/>
              <a:ext cx="11820525" cy="1981200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0EE17437-5C57-45A6-ACD2-3409E042E39D}"/>
                </a:ext>
              </a:extLst>
            </p:cNvPr>
            <p:cNvSpPr/>
            <p:nvPr/>
          </p:nvSpPr>
          <p:spPr>
            <a:xfrm>
              <a:off x="3337931" y="3326861"/>
              <a:ext cx="806051" cy="175096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D96B19CF-C041-4EC8-BFAF-23E493A0A6C7}"/>
                </a:ext>
              </a:extLst>
            </p:cNvPr>
            <p:cNvSpPr/>
            <p:nvPr/>
          </p:nvSpPr>
          <p:spPr>
            <a:xfrm>
              <a:off x="185737" y="4128783"/>
              <a:ext cx="944673" cy="151387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ysClr val="windowText" lastClr="00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51671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HOC PPT">
      <a:dk1>
        <a:srgbClr val="0064A4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CHOC_Powerpoint_Template_Rev_11.19.potx" id="{FB123508-3A3A-4C60-AB1B-08904BF6451F}" vid="{98E3C7F8-DA4A-4DC9-A84F-D9E92285A121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CCE4EBDCA4D874A89F9A6B1101744A6" ma:contentTypeVersion="12" ma:contentTypeDescription="Create a new document." ma:contentTypeScope="" ma:versionID="cec22c88ddba6dbbc2ed863096d42f3b">
  <xsd:schema xmlns:xsd="http://www.w3.org/2001/XMLSchema" xmlns:xs="http://www.w3.org/2001/XMLSchema" xmlns:p="http://schemas.microsoft.com/office/2006/metadata/properties" xmlns:ns3="a785ad58-1d57-4f8a-aa71-77170459bd0d" xmlns:ns4="2610ffbf-e2cd-4b50-a7ff-b032037205a7" xmlns:ns5="be708e37-e0ab-4742-84ee-16cbcd3a87a8" targetNamespace="http://schemas.microsoft.com/office/2006/metadata/properties" ma:root="true" ma:fieldsID="6ebfd73ed2069794449752c13ad02552" ns3:_="" ns4:_="" ns5:_="">
    <xsd:import namespace="a785ad58-1d57-4f8a-aa71-77170459bd0d"/>
    <xsd:import namespace="2610ffbf-e2cd-4b50-a7ff-b032037205a7"/>
    <xsd:import namespace="be708e37-e0ab-4742-84ee-16cbcd3a87a8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4:MediaServiceMetadata" minOccurs="0"/>
                <xsd:element ref="ns4:MediaServiceFastMetadata" minOccurs="0"/>
                <xsd:element ref="ns5:SharedWithDetails" minOccurs="0"/>
                <xsd:element ref="ns5:SharingHintHash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785ad58-1d57-4f8a-aa71-77170459bd0d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_x0024_Resources_x003a_core_x002c_SharedWithFieldDisplayName_x003b_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610ffbf-e2cd-4b50-a7ff-b032037205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e708e37-e0ab-4742-84ee-16cbcd3a87a8" elementFormDefault="qualified">
    <xsd:import namespace="http://schemas.microsoft.com/office/2006/documentManagement/types"/>
    <xsd:import namespace="http://schemas.microsoft.com/office/infopath/2007/PartnerControls"/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22FF2F9-7089-4E59-A456-99CDED839891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366C3D2-EFB4-4B61-A082-2C46D183296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785ad58-1d57-4f8a-aa71-77170459bd0d"/>
    <ds:schemaRef ds:uri="2610ffbf-e2cd-4b50-a7ff-b032037205a7"/>
    <ds:schemaRef ds:uri="be708e37-e0ab-4742-84ee-16cbcd3a87a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D18456C-EF55-43F9-AB88-C1373E3A24CF}">
  <ds:schemaRefs>
    <ds:schemaRef ds:uri="http://schemas.openxmlformats.org/package/2006/metadata/core-properties"/>
    <ds:schemaRef ds:uri="http://schemas.microsoft.com/office/2006/metadata/properties"/>
    <ds:schemaRef ds:uri="2610ffbf-e2cd-4b50-a7ff-b032037205a7"/>
    <ds:schemaRef ds:uri="http://purl.org/dc/elements/1.1/"/>
    <ds:schemaRef ds:uri="http://purl.org/dc/terms/"/>
    <ds:schemaRef ds:uri="a785ad58-1d57-4f8a-aa71-77170459bd0d"/>
    <ds:schemaRef ds:uri="http://purl.org/dc/dcmitype/"/>
    <ds:schemaRef ds:uri="http://schemas.microsoft.com/office/2006/documentManagement/types"/>
    <ds:schemaRef ds:uri="http://schemas.microsoft.com/office/infopath/2007/PartnerControls"/>
    <ds:schemaRef ds:uri="be708e37-e0ab-4742-84ee-16cbcd3a87a8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CHOC_Powerpoint_Template_Rev_11.19</Template>
  <TotalTime>4241</TotalTime>
  <Words>522</Words>
  <Application>Microsoft Macintosh PowerPoint</Application>
  <PresentationFormat>Widescreen</PresentationFormat>
  <Paragraphs>70</Paragraphs>
  <Slides>16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1" baseType="lpstr">
      <vt:lpstr>Gill Sans MT</vt:lpstr>
      <vt:lpstr>Calibri</vt:lpstr>
      <vt:lpstr>Arial</vt:lpstr>
      <vt:lpstr>Arial Nova</vt:lpstr>
      <vt:lpstr>Office Theme</vt:lpstr>
      <vt:lpstr>Fire Department EMT Skills</vt:lpstr>
      <vt:lpstr>Escape Room Debrief – let’s talk about it… </vt:lpstr>
      <vt:lpstr>PowerPoint Presentation</vt:lpstr>
      <vt:lpstr>Quick Case Study Review…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Reporting Requirements Review… </vt:lpstr>
      <vt:lpstr>Making a Report</vt:lpstr>
      <vt:lpstr>PowerPoint Presentation</vt:lpstr>
      <vt:lpstr>PowerPoint Presentation</vt:lpstr>
      <vt:lpstr>Policy Review… </vt:lpstr>
      <vt:lpstr>When to make Base Contac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y Carter-Humphreys</dc:creator>
  <cp:lastModifiedBy>Wray, Alisa</cp:lastModifiedBy>
  <cp:revision>225</cp:revision>
  <cp:lastPrinted>2019-08-07T19:18:52Z</cp:lastPrinted>
  <dcterms:created xsi:type="dcterms:W3CDTF">2019-11-20T21:36:48Z</dcterms:created>
  <dcterms:modified xsi:type="dcterms:W3CDTF">2023-01-19T02:11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CCE4EBDCA4D874A89F9A6B1101744A6</vt:lpwstr>
  </property>
</Properties>
</file>